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5" autoAdjust="0"/>
    <p:restoredTop sz="94660"/>
  </p:normalViewPr>
  <p:slideViewPr>
    <p:cSldViewPr snapToGrid="0">
      <p:cViewPr varScale="1">
        <p:scale>
          <a:sx n="54" d="100"/>
          <a:sy n="54" d="100"/>
        </p:scale>
        <p:origin x="206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320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64411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0177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88996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4435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574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77876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3575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57597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7130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4047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98FCA9-49FD-442F-B1E0-B399B198C281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174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2283914D-44F2-48BE-BF47-04D966A68142}"/>
              </a:ext>
            </a:extLst>
          </p:cNvPr>
          <p:cNvGrpSpPr/>
          <p:nvPr/>
        </p:nvGrpSpPr>
        <p:grpSpPr>
          <a:xfrm>
            <a:off x="1953795" y="696994"/>
            <a:ext cx="2292922" cy="518522"/>
            <a:chOff x="8171838" y="2181696"/>
            <a:chExt cx="3041677" cy="687845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3B504B8-9E01-453A-9EDD-7D24705F4D3D}"/>
                </a:ext>
              </a:extLst>
            </p:cNvPr>
            <p:cNvSpPr txBox="1"/>
            <p:nvPr/>
          </p:nvSpPr>
          <p:spPr>
            <a:xfrm>
              <a:off x="8729176" y="2181696"/>
              <a:ext cx="1927002" cy="348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HK" sz="1108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P-1</a:t>
              </a:r>
              <a:r>
                <a:rPr lang="en-US" altLang="zh-HK" sz="1108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+ 5nM PMA)</a:t>
              </a:r>
              <a:endParaRPr lang="zh-HK" altLang="en-US" sz="1108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54BBB0E-DB25-4D60-BA2B-612D0BB213A8}"/>
                </a:ext>
              </a:extLst>
            </p:cNvPr>
            <p:cNvSpPr txBox="1"/>
            <p:nvPr/>
          </p:nvSpPr>
          <p:spPr>
            <a:xfrm>
              <a:off x="8235839" y="2520885"/>
              <a:ext cx="2913681" cy="348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HK" sz="1108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HCC97L </a:t>
              </a:r>
              <a:r>
                <a:rPr lang="en-US" altLang="zh-HK" sz="1108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+ 200ng/mL MCP-1) </a:t>
              </a:r>
              <a:endParaRPr lang="zh-HK" altLang="en-US" sz="1108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3A36FE38-7B42-4551-8144-2C76065B77E4}"/>
                </a:ext>
              </a:extLst>
            </p:cNvPr>
            <p:cNvCxnSpPr/>
            <p:nvPr/>
          </p:nvCxnSpPr>
          <p:spPr>
            <a:xfrm>
              <a:off x="8171838" y="2520885"/>
              <a:ext cx="3041677" cy="0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6" name="TextBox 15"/>
          <p:cNvSpPr txBox="1"/>
          <p:nvPr/>
        </p:nvSpPr>
        <p:spPr>
          <a:xfrm>
            <a:off x="0" y="7819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2</a:t>
            </a:r>
          </a:p>
        </p:txBody>
      </p:sp>
      <p:grpSp>
        <p:nvGrpSpPr>
          <p:cNvPr id="17" name="Group 16"/>
          <p:cNvGrpSpPr/>
          <p:nvPr/>
        </p:nvGrpSpPr>
        <p:grpSpPr>
          <a:xfrm>
            <a:off x="1346500" y="1471209"/>
            <a:ext cx="3517107" cy="1142343"/>
            <a:chOff x="1346500" y="1471209"/>
            <a:chExt cx="3517107" cy="1142343"/>
          </a:xfrm>
        </p:grpSpPr>
        <p:grpSp>
          <p:nvGrpSpPr>
            <p:cNvPr id="15" name="Group 14"/>
            <p:cNvGrpSpPr/>
            <p:nvPr/>
          </p:nvGrpSpPr>
          <p:grpSpPr>
            <a:xfrm>
              <a:off x="2520890" y="1472608"/>
              <a:ext cx="1158734" cy="1136670"/>
              <a:chOff x="364718" y="2824371"/>
              <a:chExt cx="1158734" cy="1136670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65681" y="2824371"/>
                <a:ext cx="1157771" cy="1136670"/>
              </a:xfrm>
              <a:prstGeom prst="rect">
                <a:avLst/>
              </a:prstGeom>
            </p:spPr>
          </p:pic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315C05A1-B32E-49A2-B830-EC951D3C695C}"/>
                  </a:ext>
                </a:extLst>
              </p:cNvPr>
              <p:cNvSpPr txBox="1"/>
              <p:nvPr/>
            </p:nvSpPr>
            <p:spPr>
              <a:xfrm>
                <a:off x="364718" y="2824371"/>
                <a:ext cx="285656" cy="29117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defTabSz="422041">
                  <a:defRPr/>
                </a:pPr>
                <a:r>
                  <a:rPr lang="en-US" altLang="zh-TW" sz="1292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P</a:t>
                </a:r>
                <a:endParaRPr lang="zh-HK" altLang="en-US" sz="1292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4" name="Group 23"/>
            <p:cNvGrpSpPr/>
            <p:nvPr/>
          </p:nvGrpSpPr>
          <p:grpSpPr>
            <a:xfrm>
              <a:off x="1346500" y="1471209"/>
              <a:ext cx="1147915" cy="1142343"/>
              <a:chOff x="3116950" y="3115541"/>
              <a:chExt cx="1147915" cy="1142343"/>
            </a:xfrm>
          </p:grpSpPr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116950" y="3115541"/>
                <a:ext cx="1136670" cy="1135264"/>
              </a:xfrm>
              <a:prstGeom prst="rect">
                <a:avLst/>
              </a:prstGeom>
            </p:spPr>
          </p:pic>
          <p:grpSp>
            <p:nvGrpSpPr>
              <p:cNvPr id="8" name="Group 7"/>
              <p:cNvGrpSpPr/>
              <p:nvPr/>
            </p:nvGrpSpPr>
            <p:grpSpPr>
              <a:xfrm>
                <a:off x="3714714" y="4023524"/>
                <a:ext cx="550151" cy="234360"/>
                <a:chOff x="3151417" y="4444042"/>
                <a:chExt cx="595997" cy="253890"/>
              </a:xfrm>
            </p:grpSpPr>
            <p:cxnSp>
              <p:nvCxnSpPr>
                <p:cNvPr id="4" name="Straight Connector 3"/>
                <p:cNvCxnSpPr/>
                <p:nvPr/>
              </p:nvCxnSpPr>
              <p:spPr>
                <a:xfrm>
                  <a:off x="3501078" y="4641112"/>
                  <a:ext cx="15988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" name="Rectangle 4"/>
                <p:cNvSpPr/>
                <p:nvPr/>
              </p:nvSpPr>
              <p:spPr>
                <a:xfrm>
                  <a:off x="3151417" y="4444042"/>
                  <a:ext cx="595997" cy="25389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23" dirty="0"/>
                    <a:t>200 µm</a:t>
                  </a:r>
                </a:p>
              </p:txBody>
            </p:sp>
          </p:grp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315C05A1-B32E-49A2-B830-EC951D3C695C}"/>
                  </a:ext>
                </a:extLst>
              </p:cNvPr>
              <p:cNvSpPr txBox="1"/>
              <p:nvPr/>
            </p:nvSpPr>
            <p:spPr>
              <a:xfrm>
                <a:off x="3120725" y="3124314"/>
                <a:ext cx="917239" cy="29117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defTabSz="422041">
                  <a:defRPr/>
                </a:pPr>
                <a:r>
                  <a:rPr lang="en-US" altLang="zh-TW" sz="1292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P+Y27632</a:t>
                </a:r>
                <a:endParaRPr lang="zh-HK" altLang="en-US" sz="1292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" name="Group 2"/>
            <p:cNvGrpSpPr/>
            <p:nvPr/>
          </p:nvGrpSpPr>
          <p:grpSpPr>
            <a:xfrm>
              <a:off x="3706098" y="1473599"/>
              <a:ext cx="1157509" cy="1127760"/>
              <a:chOff x="1548231" y="2828826"/>
              <a:chExt cx="1157509" cy="1127760"/>
            </a:xfrm>
          </p:grpSpPr>
          <p:pic>
            <p:nvPicPr>
              <p:cNvPr id="26" name="Picture 25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549024" y="2828826"/>
                <a:ext cx="1156716" cy="1127760"/>
              </a:xfrm>
              <a:prstGeom prst="rect">
                <a:avLst/>
              </a:prstGeom>
            </p:spPr>
          </p:pic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315C05A1-B32E-49A2-B830-EC951D3C695C}"/>
                  </a:ext>
                </a:extLst>
              </p:cNvPr>
              <p:cNvSpPr txBox="1"/>
              <p:nvPr/>
            </p:nvSpPr>
            <p:spPr>
              <a:xfrm>
                <a:off x="1548231" y="2835397"/>
                <a:ext cx="359394" cy="29117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defTabSz="422041">
                  <a:defRPr/>
                </a:pPr>
                <a:r>
                  <a:rPr lang="en-US" altLang="zh-TW" sz="1292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S1</a:t>
                </a:r>
                <a:endParaRPr lang="zh-HK" altLang="en-US" sz="1292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2" name="Rectangle 1"/>
          <p:cNvSpPr/>
          <p:nvPr/>
        </p:nvSpPr>
        <p:spPr>
          <a:xfrm>
            <a:off x="291613" y="5964542"/>
            <a:ext cx="602606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06070" algn="just"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Supplementary Fig 2. </a:t>
            </a:r>
            <a:r>
              <a:rPr lang="en-US" sz="1200" b="1" kern="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Effects of the ROCK inhibitor (Y27632) on THP-1 migration in the Boyden chamber.  </a:t>
            </a:r>
            <a:r>
              <a:rPr lang="en-US" sz="1200" kern="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PMA (5 </a:t>
            </a:r>
            <a:r>
              <a:rPr lang="en-US" sz="1200" kern="0" dirty="0" err="1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nM</a:t>
            </a:r>
            <a:r>
              <a:rPr lang="en-US" sz="1200" kern="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) treated THP1 cells was seeded in cell culture inserts of 8 µm, and co-cultured with MHCC97L (with 200 ng/mL chemoattractant MCP-1) for 24 hr. Migrated THP-1 cells were stained in 0.5% crystal violet and countered using light microscopy.  THP-1 cells treated with the inhibitor Y27632 (10 </a:t>
            </a:r>
            <a:r>
              <a:rPr lang="en-US" sz="1200" kern="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US" sz="1200" kern="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M) and co-cultured with MHCC97L/P, showed a significant reduction in the migration (the left panel) as compared with the cells without the inhibitor treatment (the middle panel). The right panel showed the anti-migratory effects of MHCC97L/S1 on THP-1 cells. *P &lt; 0.05 as compared with the respective control.</a:t>
            </a:r>
            <a:endParaRPr lang="en-US" sz="1200" kern="100" dirty="0"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87529" y="3165154"/>
            <a:ext cx="3479981" cy="2243564"/>
          </a:xfrm>
          <a:prstGeom prst="rect">
            <a:avLst/>
          </a:prstGeom>
        </p:spPr>
      </p:pic>
      <p:sp>
        <p:nvSpPr>
          <p:cNvPr id="19" name="Rectangle 18"/>
          <p:cNvSpPr/>
          <p:nvPr/>
        </p:nvSpPr>
        <p:spPr>
          <a:xfrm>
            <a:off x="2694540" y="3078351"/>
            <a:ext cx="180850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HK" sz="14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P-1 cell migration</a:t>
            </a:r>
            <a:endParaRPr lang="en-US" sz="1400" u="sng" dirty="0"/>
          </a:p>
        </p:txBody>
      </p:sp>
    </p:spTree>
    <p:extLst>
      <p:ext uri="{BB962C8B-B14F-4D97-AF65-F5344CB8AC3E}">
        <p14:creationId xmlns:p14="http://schemas.microsoft.com/office/powerpoint/2010/main" val="1118358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3</TotalTime>
  <Words>167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ong Chris K C</dc:creator>
  <cp:lastModifiedBy>SATHISH</cp:lastModifiedBy>
  <cp:revision>16</cp:revision>
  <dcterms:created xsi:type="dcterms:W3CDTF">2019-07-29T08:48:58Z</dcterms:created>
  <dcterms:modified xsi:type="dcterms:W3CDTF">2020-10-28T09:25:53Z</dcterms:modified>
</cp:coreProperties>
</file>